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76" r:id="rId2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955" userDrawn="1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0099FF"/>
    <a:srgbClr val="00CC99"/>
    <a:srgbClr val="800080"/>
    <a:srgbClr val="6364F8"/>
    <a:srgbClr val="FF00FF"/>
    <a:srgbClr val="5CC179"/>
    <a:srgbClr val="00FDFF"/>
    <a:srgbClr val="FF93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373" autoAdjust="0"/>
    <p:restoredTop sz="97723" autoAdjust="0"/>
  </p:normalViewPr>
  <p:slideViewPr>
    <p:cSldViewPr snapToGrid="0" snapToObjects="1">
      <p:cViewPr varScale="1">
        <p:scale>
          <a:sx n="91" d="100"/>
          <a:sy n="91" d="100"/>
        </p:scale>
        <p:origin x="3192" y="184"/>
      </p:cViewPr>
      <p:guideLst>
        <p:guide orient="horz" pos="5955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B32FF0B-0073-674D-8155-C198B42C9D6A}" type="datetimeFigureOut">
              <a:rPr lang="en-US" smtClean="0"/>
              <a:t>5/6/24</a:t>
            </a:fld>
            <a:endParaRPr lang="en-US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lang="fr-FR"/>
              <a:t>Modifier les styles du texte du masque
Deuxième niveau
Troisième niveau
Quatrième niveau
Cinquième niveau</a:t>
            </a:r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C688EAF-3660-E44E-882C-6BCEE97E6D0C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73084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C688EAF-3660-E44E-882C-6BCEE97E6D0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95039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8ED41-76FA-5146-BC5D-867466E4E395}" type="datetime1">
              <a:rPr lang="fr-FR" smtClean="0"/>
              <a:t>06/0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2166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6273E-2DC6-9945-8C10-F59366102194}" type="datetime1">
              <a:rPr lang="fr-FR" smtClean="0"/>
              <a:t>06/0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4040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95B729-D324-014C-9978-1B3FED3DC642}" type="datetime1">
              <a:rPr lang="fr-FR" smtClean="0"/>
              <a:t>06/0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85742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2EDB47-CD55-984B-884B-4B414F215CED}" type="datetime1">
              <a:rPr lang="fr-FR" smtClean="0"/>
              <a:t>06/0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41221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15A23-FC0B-504A-84AA-BB3131D33D80}" type="datetime1">
              <a:rPr lang="fr-FR" smtClean="0"/>
              <a:t>06/0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60528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0997A-1A5A-A740-9866-3A35D0D45881}" type="datetime1">
              <a:rPr lang="fr-FR" smtClean="0"/>
              <a:t>06/0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20285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F646E-CB27-8F4E-A104-844DFCB1F399}" type="datetime1">
              <a:rPr lang="fr-FR" smtClean="0"/>
              <a:t>06/05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40698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7A702A-5B67-5849-9E34-EE575A2BD018}" type="datetime1">
              <a:rPr lang="fr-FR" smtClean="0"/>
              <a:t>06/05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92904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C7873-0CEE-6D40-96D5-4BB2FAAB8869}" type="datetime1">
              <a:rPr lang="fr-FR" smtClean="0"/>
              <a:t>06/05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98685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45469-297B-D247-954E-26D203AE886F}" type="datetime1">
              <a:rPr lang="fr-FR" smtClean="0"/>
              <a:t>06/0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12944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EDA7D-F6B0-A84F-83E5-76D147850A61}" type="datetime1">
              <a:rPr lang="fr-FR" smtClean="0"/>
              <a:t>06/0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37405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1AA41F-B621-B84F-A17E-1E3E344CB607}" type="datetime1">
              <a:rPr lang="fr-FR" smtClean="0"/>
              <a:t>06/0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74729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hf hdr="0" ftr="0" dt="0"/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Image 8">
            <a:extLst>
              <a:ext uri="{FF2B5EF4-FFF2-40B4-BE49-F238E27FC236}">
                <a16:creationId xmlns:a16="http://schemas.microsoft.com/office/drawing/2014/main" id="{69E6E175-7D95-C190-59A4-BAEDA39CE2B6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89441" y="1656361"/>
            <a:ext cx="2268142" cy="1800000"/>
          </a:xfrm>
          <a:prstGeom prst="rect">
            <a:avLst/>
          </a:prstGeom>
        </p:spPr>
      </p:pic>
      <p:sp>
        <p:nvSpPr>
          <p:cNvPr id="10" name="ZoneTexte 9">
            <a:extLst>
              <a:ext uri="{FF2B5EF4-FFF2-40B4-BE49-F238E27FC236}">
                <a16:creationId xmlns:a16="http://schemas.microsoft.com/office/drawing/2014/main" id="{C4393443-F695-CFBE-A077-41136B6EF984}"/>
              </a:ext>
            </a:extLst>
          </p:cNvPr>
          <p:cNvSpPr txBox="1"/>
          <p:nvPr/>
        </p:nvSpPr>
        <p:spPr>
          <a:xfrm>
            <a:off x="2345663" y="917501"/>
            <a:ext cx="22236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9</a:t>
            </a:r>
          </a:p>
        </p:txBody>
      </p:sp>
      <p:pic>
        <p:nvPicPr>
          <p:cNvPr id="12" name="Image 11">
            <a:extLst>
              <a:ext uri="{FF2B5EF4-FFF2-40B4-BE49-F238E27FC236}">
                <a16:creationId xmlns:a16="http://schemas.microsoft.com/office/drawing/2014/main" id="{36745A66-1A29-0CBF-BDF0-33895AA6BF7B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98904" y="1656361"/>
            <a:ext cx="2944784" cy="1800000"/>
          </a:xfrm>
          <a:prstGeom prst="rect">
            <a:avLst/>
          </a:prstGeom>
        </p:spPr>
      </p:pic>
      <p:sp>
        <p:nvSpPr>
          <p:cNvPr id="13" name="ZoneTexte 12">
            <a:extLst>
              <a:ext uri="{FF2B5EF4-FFF2-40B4-BE49-F238E27FC236}">
                <a16:creationId xmlns:a16="http://schemas.microsoft.com/office/drawing/2014/main" id="{908B46A0-D4E4-7EE0-4042-5DF42163F6C9}"/>
              </a:ext>
            </a:extLst>
          </p:cNvPr>
          <p:cNvSpPr txBox="1"/>
          <p:nvPr/>
        </p:nvSpPr>
        <p:spPr>
          <a:xfrm>
            <a:off x="448790" y="1450102"/>
            <a:ext cx="1554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445C7D06-DC74-5CEB-DC36-D730F32CC01D}"/>
              </a:ext>
            </a:extLst>
          </p:cNvPr>
          <p:cNvSpPr txBox="1"/>
          <p:nvPr/>
        </p:nvSpPr>
        <p:spPr>
          <a:xfrm>
            <a:off x="3711706" y="1450102"/>
            <a:ext cx="1554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AAD836A3-5BDD-BE45-A53A-BB5BC96B101A}"/>
              </a:ext>
            </a:extLst>
          </p:cNvPr>
          <p:cNvSpPr txBox="1"/>
          <p:nvPr/>
        </p:nvSpPr>
        <p:spPr>
          <a:xfrm>
            <a:off x="4813343" y="1480880"/>
            <a:ext cx="5116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D86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id="{3DFF8CFD-A3D0-86D5-3F88-A9A2DB2D5841}"/>
              </a:ext>
            </a:extLst>
          </p:cNvPr>
          <p:cNvSpPr txBox="1"/>
          <p:nvPr/>
        </p:nvSpPr>
        <p:spPr>
          <a:xfrm>
            <a:off x="448790" y="3608768"/>
            <a:ext cx="5960420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 9. Conditioned medium from HTLV-1-infected T cells is not sufficient to dampen the responsiveness of MDDCs to subsequent stimulation. a.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Quantification by Luminex of IL-10 levels in supernatants of MDDCs cocultured with uninfected T cells (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Jurkat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), or with HTLV-1-infected T cells (C91-PL, MT-2, Hut102, C8166), followed or not by LPS stimulation (n=3 independent experiments).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b.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Uninfected (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Jurkat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, red) or HTLV-1-infected T cells (C91-PL, MT-2, Hut102, dark blue; or C8166, purple) were cultured for 24h. Conditioned medium was collected and added on naive MDDCs for 24h, before restimulation with LPS for an additional 24h. Quantification results from n=4 independent experiments of flow cytometry data for CD11c and CD86 staining are presented. Data were analyzed with RM one-way ANOVA, as presented in Supplementary Table 8.</a:t>
            </a:r>
            <a:endParaRPr lang="fr-FR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/>
            <a:endParaRPr lang="fr-FR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2" name="Espace réservé du numéro de diapositive 1">
            <a:extLst>
              <a:ext uri="{FF2B5EF4-FFF2-40B4-BE49-F238E27FC236}">
                <a16:creationId xmlns:a16="http://schemas.microsoft.com/office/drawing/2014/main" id="{A137F27C-D171-44E4-D43F-AF3B270BBB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494939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1234</TotalTime>
  <Words>166</Words>
  <Application>Microsoft Macintosh PowerPoint</Application>
  <PresentationFormat>Format A4 (210 x 297 mm)</PresentationFormat>
  <Paragraphs>7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subject/>
  <dc:creator>Microsoft Office User</dc:creator>
  <cp:keywords/>
  <dc:description/>
  <cp:lastModifiedBy>helene</cp:lastModifiedBy>
  <cp:revision>227</cp:revision>
  <cp:lastPrinted>2024-05-03T15:39:09Z</cp:lastPrinted>
  <dcterms:created xsi:type="dcterms:W3CDTF">2023-02-24T13:22:32Z</dcterms:created>
  <dcterms:modified xsi:type="dcterms:W3CDTF">2024-05-06T10:06:55Z</dcterms:modified>
  <cp:category/>
</cp:coreProperties>
</file>